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1" d="100"/>
          <a:sy n="111" d="100"/>
        </p:scale>
        <p:origin x="456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B8FD559-536E-4109-A3BC-AC26D282360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4C5BAB78-63D3-49D9-A30E-B9CC4BB1FB7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B850DDC-2352-4FEE-A9DE-D615F9BA52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CBD1-972A-4EA9-98A9-6C9B22AA6585}" type="datetimeFigureOut">
              <a:rPr lang="ko-KR" altLang="en-US" smtClean="0"/>
              <a:t>2022-04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EA075937-AD5E-45FF-849D-DA968B9016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C59F999B-D082-4978-9226-57B7E73A6B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D243B-BC7B-4E9F-80D6-1F4152A5A6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846967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993C3963-2850-4F44-8E93-509E1726388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6EA33A82-A8E4-4B7A-B60F-C8B49C8BD49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F5E41083-38E7-49AC-9BE6-84CD3AF12C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CBD1-972A-4EA9-98A9-6C9B22AA6585}" type="datetimeFigureOut">
              <a:rPr lang="ko-KR" altLang="en-US" smtClean="0"/>
              <a:t>2022-04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790A02A2-AA22-4017-9913-88161723A7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D9DE6BA-C158-49B0-AB7E-C7828DF69A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D243B-BC7B-4E9F-80D6-1F4152A5A6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878855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A6E8D351-3F15-4C01-A704-6B0F2310A0D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E30E91E-A566-4816-B0A0-4FECF9AA19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D8F520A8-54C1-4E3A-846A-ACCA134EC4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CBD1-972A-4EA9-98A9-6C9B22AA6585}" type="datetimeFigureOut">
              <a:rPr lang="ko-KR" altLang="en-US" smtClean="0"/>
              <a:t>2022-04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B2C6C30-644D-49BC-B43D-B39B71B790A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A9C34CC-F981-4BBE-96AC-B4974BDAB7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D243B-BC7B-4E9F-80D6-1F4152A5A6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15706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F04F96A-49FE-44AE-BFF7-969BE2725E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4F2EE96A-B691-40A6-AEFF-E3A52A84A1E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588644D2-099F-4CE0-8DA6-658A6AEFC0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CBD1-972A-4EA9-98A9-6C9B22AA6585}" type="datetimeFigureOut">
              <a:rPr lang="ko-KR" altLang="en-US" smtClean="0"/>
              <a:t>2022-04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04D11070-40B9-4AEB-9233-806CABD83A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5249901F-2072-4D03-902F-509EFD8BE9E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D243B-BC7B-4E9F-80D6-1F4152A5A6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75107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EE04173C-7630-43E9-9B3D-905C92B971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6735EDD0-5741-4808-B8FF-70D9DE46320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703B064-E31B-48A7-BDE8-5FCB38F2AB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CBD1-972A-4EA9-98A9-6C9B22AA6585}" type="datetimeFigureOut">
              <a:rPr lang="ko-KR" altLang="en-US" smtClean="0"/>
              <a:t>2022-04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B9816783-3B3D-4C43-ADB0-63C4CF29F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0138FA99-3B17-4887-B120-2ECC45A418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D243B-BC7B-4E9F-80D6-1F4152A5A6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59273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2F0576C7-2928-433F-8F0D-F2590F338A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C20CBE0C-DFCA-4E8B-B5EB-72521C07A1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427FF945-FFAD-44B6-8E8D-F8CFA02D55F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DF34DDE0-2F3D-415D-B275-B1D49B2058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CBD1-972A-4EA9-98A9-6C9B22AA6585}" type="datetimeFigureOut">
              <a:rPr lang="ko-KR" altLang="en-US" smtClean="0"/>
              <a:t>2022-04-2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F10756D0-5ABC-4448-9838-471A606F7D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63544E48-5B4A-4D36-9679-7E1F6E7C21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D243B-BC7B-4E9F-80D6-1F4152A5A6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79825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47BEB4F3-6B5F-4680-B78E-CAC0C39A40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F9AFBE5B-5B0B-4159-A811-8C985D6DFD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1482CB44-CCB1-4834-891A-2B46536D477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9EF08FD8-FE64-4BAD-B533-8FE0E882470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49E8C055-BBA2-451E-B821-0EDA1D4BF64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99C4EFA1-1FCD-431A-8B91-665B16CFB8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CBD1-972A-4EA9-98A9-6C9B22AA6585}" type="datetimeFigureOut">
              <a:rPr lang="ko-KR" altLang="en-US" smtClean="0"/>
              <a:t>2022-04-26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DA56ECFD-D205-443F-A57B-F2FAFCABA4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98408B3D-0E8D-4A27-805D-643D76E58E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D243B-BC7B-4E9F-80D6-1F4152A5A6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624633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356A7F6-EF11-47A2-BCC3-DA339944B0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C192478C-2CEE-430C-9DF7-324D08E04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CBD1-972A-4EA9-98A9-6C9B22AA6585}" type="datetimeFigureOut">
              <a:rPr lang="ko-KR" altLang="en-US" smtClean="0"/>
              <a:t>2022-04-26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7CA26160-DF40-4588-AC7F-693E96A6A7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670DF59A-B2A5-49EF-9A3D-A578BA7496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D243B-BC7B-4E9F-80D6-1F4152A5A6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89456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8520D859-DF42-43A1-ACFE-CB46CBF665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CBD1-972A-4EA9-98A9-6C9B22AA6585}" type="datetimeFigureOut">
              <a:rPr lang="ko-KR" altLang="en-US" smtClean="0"/>
              <a:t>2022-04-26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AFA4F1DF-C8B8-4276-98C0-ABE7AFCB50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C9327E5B-EE81-4DDD-92C5-86B0980406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D243B-BC7B-4E9F-80D6-1F4152A5A6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76412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021F061-25F2-45DD-9314-D5F79ED158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77D74908-7E70-461F-9B32-A4ECE2B3C7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4B0D0F32-0450-4130-B752-AD61216AC30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E561BF6-488C-45DD-B5AB-B84328E6579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CBD1-972A-4EA9-98A9-6C9B22AA6585}" type="datetimeFigureOut">
              <a:rPr lang="ko-KR" altLang="en-US" smtClean="0"/>
              <a:t>2022-04-2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D099A2F8-2581-457E-8153-22BCC23B9C0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4D7508F1-4A48-4DD8-A879-AC55858BC7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D243B-BC7B-4E9F-80D6-1F4152A5A6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410911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A51A8943-1602-4503-9539-5BE679BC16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17DEDA0E-272B-462E-BA20-3F89CEE3D3D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0057206B-229D-4584-82B9-8324427E8D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B9DFAD88-7EED-4E75-A123-7C513029E1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39CBD1-972A-4EA9-98A9-6C9B22AA6585}" type="datetimeFigureOut">
              <a:rPr lang="ko-KR" altLang="en-US" smtClean="0"/>
              <a:t>2022-04-2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010862E6-89B6-4510-A812-0B24C85FA7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164B28EC-2CBC-4A14-A806-093700C861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73D243B-BC7B-4E9F-80D6-1F4152A5A6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5623166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286F78BF-6ACE-4D6C-B75A-78C9EBB07A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2AF995A1-5D47-468A-83D3-C3FF75BD40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029D8C5-F2B5-4E4E-8DEA-02E7F66418D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39CBD1-972A-4EA9-98A9-6C9B22AA6585}" type="datetimeFigureOut">
              <a:rPr lang="ko-KR" altLang="en-US" smtClean="0"/>
              <a:t>2022-04-2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D8603234-D4F4-4D57-BE79-2415E720E34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DBD717A-9859-434F-ABEF-FDAC0F0EA9E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3D243B-BC7B-4E9F-80D6-1F4152A5A64D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87633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182C2818-E76B-4456-A2FE-4D6CE5F47992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data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6296E400-AE37-442A-90CD-A40B6A88FEA8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altLang="ko-KR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-9805 restores motor manifestations in 6-hydroxydopamine-induced Parkinson’s disease mouse by regulating striatal dopamine and acetylcholine releases</a:t>
            </a:r>
            <a:endParaRPr lang="ko-KR" alt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8508470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3E57BAB8-2C49-4024-B141-9F87F693EAB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9820" y="1646227"/>
            <a:ext cx="11132360" cy="3565546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58D3F0CB-683E-4544-BF85-8731D98577A7}"/>
              </a:ext>
            </a:extLst>
          </p:cNvPr>
          <p:cNvSpPr/>
          <p:nvPr/>
        </p:nvSpPr>
        <p:spPr>
          <a:xfrm>
            <a:off x="529820" y="5750501"/>
            <a:ext cx="11193478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spcAft>
                <a:spcPts val="800"/>
              </a:spcAft>
            </a:pPr>
            <a:r>
              <a:rPr lang="en-US" altLang="ko-KR" b="1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Supplementary data1. </a:t>
            </a:r>
            <a:r>
              <a:rPr lang="en-US" altLang="ko-KR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Chromatograms for standard components (A) and mouse striatum (B). Peaks: 1. Acetylcholine; 2. Glutamate; 3. </a:t>
            </a:r>
            <a:r>
              <a:rPr lang="en-US" altLang="ko-KR" kern="100" dirty="0">
                <a:latin typeface="Times New Roman" panose="02020603050405020304" pitchFamily="18" charset="0"/>
                <a:ea typeface="바탕" panose="02030600000101010101" pitchFamily="18" charset="-127"/>
                <a:cs typeface="Times New Roman" panose="02020603050405020304" pitchFamily="18" charset="0"/>
              </a:rPr>
              <a:t>γ-aminobutyric acid; Internal standard (I.S.), digitoxin.</a:t>
            </a:r>
            <a:endParaRPr lang="ko-KR" altLang="ko-KR" sz="1200" kern="100" dirty="0">
              <a:effectLst/>
              <a:latin typeface="Arial" panose="020B0604020202020204" pitchFamily="34" charset="0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02799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>
            <a:extLst>
              <a:ext uri="{FF2B5EF4-FFF2-40B4-BE49-F238E27FC236}">
                <a16:creationId xmlns:a16="http://schemas.microsoft.com/office/drawing/2014/main" id="{54D194C9-D560-493C-89BC-88EC6FC68F9E}"/>
              </a:ext>
            </a:extLst>
          </p:cNvPr>
          <p:cNvSpPr/>
          <p:nvPr/>
        </p:nvSpPr>
        <p:spPr>
          <a:xfrm>
            <a:off x="529820" y="5750501"/>
            <a:ext cx="11193478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spcAft>
                <a:spcPts val="800"/>
              </a:spcAft>
            </a:pPr>
            <a:r>
              <a:rPr lang="en-US" altLang="ko-KR" b="1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Supplementary data2. </a:t>
            </a:r>
            <a:r>
              <a:rPr lang="en-US" altLang="ko-KR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Information</a:t>
            </a:r>
            <a:r>
              <a:rPr lang="ko-KR" altLang="en-US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of</a:t>
            </a:r>
            <a:r>
              <a:rPr lang="ko-KR" altLang="en-US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 </a:t>
            </a:r>
            <a:r>
              <a:rPr lang="en-US" altLang="ko-KR" kern="100" dirty="0">
                <a:latin typeface="Times New Roman" panose="02020603050405020304" pitchFamily="18" charset="0"/>
                <a:ea typeface="HY신명조" panose="02030600000101010101" pitchFamily="18" charset="-127"/>
                <a:cs typeface="Times New Roman" panose="02020603050405020304" pitchFamily="18" charset="0"/>
              </a:rPr>
              <a:t>Chromatograms for standard components</a:t>
            </a:r>
            <a:endParaRPr lang="ko-KR" altLang="ko-KR" sz="1200" kern="100" dirty="0">
              <a:effectLst/>
              <a:latin typeface="Arial" panose="020B0604020202020204" pitchFamily="34" charset="0"/>
              <a:ea typeface="바탕" panose="02030600000101010101" pitchFamily="18" charset="-127"/>
              <a:cs typeface="Times New Roman" panose="02020603050405020304" pitchFamily="18" charset="0"/>
            </a:endParaRPr>
          </a:p>
        </p:txBody>
      </p:sp>
      <p:graphicFrame>
        <p:nvGraphicFramePr>
          <p:cNvPr id="5" name="표 4">
            <a:extLst>
              <a:ext uri="{FF2B5EF4-FFF2-40B4-BE49-F238E27FC236}">
                <a16:creationId xmlns:a16="http://schemas.microsoft.com/office/drawing/2014/main" id="{EA2002F6-761C-4D40-A3BF-ED6FEF79BFE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42860682"/>
              </p:ext>
            </p:extLst>
          </p:nvPr>
        </p:nvGraphicFramePr>
        <p:xfrm>
          <a:off x="529820" y="2447765"/>
          <a:ext cx="8936157" cy="1962470"/>
        </p:xfrm>
        <a:graphic>
          <a:graphicData uri="http://schemas.openxmlformats.org/drawingml/2006/table">
            <a:tbl>
              <a:tblPr firstRow="1" firstCol="1" bandRow="1"/>
              <a:tblGrid>
                <a:gridCol w="1508423">
                  <a:extLst>
                    <a:ext uri="{9D8B030D-6E8A-4147-A177-3AD203B41FA5}">
                      <a16:colId xmlns:a16="http://schemas.microsoft.com/office/drawing/2014/main" val="497630491"/>
                    </a:ext>
                  </a:extLst>
                </a:gridCol>
                <a:gridCol w="2975740">
                  <a:extLst>
                    <a:ext uri="{9D8B030D-6E8A-4147-A177-3AD203B41FA5}">
                      <a16:colId xmlns:a16="http://schemas.microsoft.com/office/drawing/2014/main" val="64145448"/>
                    </a:ext>
                  </a:extLst>
                </a:gridCol>
                <a:gridCol w="2453869">
                  <a:extLst>
                    <a:ext uri="{9D8B030D-6E8A-4147-A177-3AD203B41FA5}">
                      <a16:colId xmlns:a16="http://schemas.microsoft.com/office/drawing/2014/main" val="1852980057"/>
                    </a:ext>
                  </a:extLst>
                </a:gridCol>
                <a:gridCol w="1998125">
                  <a:extLst>
                    <a:ext uri="{9D8B030D-6E8A-4147-A177-3AD203B41FA5}">
                      <a16:colId xmlns:a16="http://schemas.microsoft.com/office/drawing/2014/main" val="1709836169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Peak No.</a:t>
                      </a:r>
                      <a:endParaRPr lang="ko-KR" sz="2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Components</a:t>
                      </a:r>
                      <a:endParaRPr lang="ko-KR" sz="2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Final concentration</a:t>
                      </a:r>
                      <a:endParaRPr lang="ko-KR" sz="2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(μg/mL)</a:t>
                      </a:r>
                      <a:endParaRPr lang="ko-KR" sz="2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Retention time</a:t>
                      </a:r>
                      <a:endParaRPr lang="ko-KR" sz="2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b="1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(min)</a:t>
                      </a:r>
                      <a:endParaRPr lang="ko-KR" sz="2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8071958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</a:t>
                      </a:r>
                      <a:endParaRPr lang="ko-KR" sz="2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Acetylcholine</a:t>
                      </a:r>
                      <a:endParaRPr lang="ko-KR" sz="2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0</a:t>
                      </a:r>
                      <a:endParaRPr lang="ko-KR" sz="2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.56</a:t>
                      </a:r>
                      <a:endParaRPr lang="ko-KR" sz="2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51991393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2</a:t>
                      </a:r>
                      <a:endParaRPr lang="ko-KR" sz="2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Glutamate</a:t>
                      </a:r>
                      <a:endParaRPr lang="ko-KR" sz="2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</a:t>
                      </a:r>
                      <a:endParaRPr lang="ko-KR" sz="2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14</a:t>
                      </a:r>
                      <a:endParaRPr lang="ko-KR" sz="2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60718082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</a:t>
                      </a:r>
                      <a:endParaRPr lang="ko-KR" sz="2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γ-aminobutyric acid</a:t>
                      </a:r>
                      <a:endParaRPr lang="ko-KR" sz="2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</a:t>
                      </a:r>
                      <a:endParaRPr lang="ko-KR" sz="2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3.23</a:t>
                      </a:r>
                      <a:endParaRPr lang="ko-KR" sz="2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534493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I.S.</a:t>
                      </a:r>
                      <a:endParaRPr lang="ko-KR" sz="2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Digitoxin</a:t>
                      </a:r>
                      <a:endParaRPr lang="ko-KR" sz="2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kern="10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1000</a:t>
                      </a:r>
                      <a:endParaRPr lang="ko-KR" sz="2000" kern="10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2000" kern="1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맑은 고딕" panose="020B0503020000020004" pitchFamily="50" charset="-127"/>
                          <a:cs typeface="Times New Roman" panose="02020603050405020304" pitchFamily="18" charset="0"/>
                        </a:rPr>
                        <a:t>8.16</a:t>
                      </a:r>
                      <a:endParaRPr lang="ko-KR" sz="2000" kern="1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맑은 고딕" panose="020B0503020000020004" pitchFamily="50" charset="-127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3724298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0660203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77</TotalTime>
  <Words>103</Words>
  <Application>Microsoft Office PowerPoint</Application>
  <PresentationFormat>와이드스크린</PresentationFormat>
  <Paragraphs>26</Paragraphs>
  <Slides>3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9" baseType="lpstr">
      <vt:lpstr>HY신명조</vt:lpstr>
      <vt:lpstr>맑은 고딕</vt:lpstr>
      <vt:lpstr>바탕</vt:lpstr>
      <vt:lpstr>Arial</vt:lpstr>
      <vt:lpstr>Times New Roman</vt:lpstr>
      <vt:lpstr>Office 테마</vt:lpstr>
      <vt:lpstr>Supplementary data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data</dc:title>
  <dc:creator>USER</dc:creator>
  <cp:lastModifiedBy> </cp:lastModifiedBy>
  <cp:revision>8</cp:revision>
  <dcterms:created xsi:type="dcterms:W3CDTF">2021-06-28T04:09:45Z</dcterms:created>
  <dcterms:modified xsi:type="dcterms:W3CDTF">2022-04-26T08:27:54Z</dcterms:modified>
</cp:coreProperties>
</file>